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08" y="20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3D398C-06FB-4C1C-B796-47FB94186120}" type="datetimeFigureOut">
              <a:rPr lang="en-US" smtClean="0"/>
              <a:t>12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BC2DAE-0BCA-47EA-88F8-5088B8D34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955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BC2DAE-0BCA-47EA-88F8-5088B8D342B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016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2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3847364"/>
              </p:ext>
            </p:extLst>
          </p:nvPr>
        </p:nvGraphicFramePr>
        <p:xfrm>
          <a:off x="476672" y="6670596"/>
          <a:ext cx="6120680" cy="2057400"/>
        </p:xfrm>
        <a:graphic>
          <a:graphicData uri="http://schemas.openxmlformats.org/drawingml/2006/table">
            <a:tbl>
              <a:tblPr/>
              <a:tblGrid>
                <a:gridCol w="64807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38437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08823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ene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rotei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unction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nd/or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henotype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bp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mopami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binding protein (sterol isomer)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onradi-Hünermann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syndrom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pif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eptidyl-proly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i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-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ran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somer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, mitochondrial 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poptotic and necrotic cell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deat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in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eptidyl-prolyl </a:t>
                      </a:r>
                      <a:r>
                        <a:rPr lang="pt-BR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is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-</a:t>
                      </a:r>
                      <a:r>
                        <a:rPr lang="pt-BR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rans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isomerase NIMA-interacting 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ell cycle and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oncogene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syna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nositol-3-phosphate synthase 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nositol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etabolis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Pi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riosephosph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isomerase 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lycolysis, HMP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shu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bp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506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inding protein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Organogene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bp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506 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inding protein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rotein folding and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rafficking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bp1a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506 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inding protein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rotein folding and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raffick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bp1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FK506 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inding protein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Osteoblast developm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</a:tbl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24821" y="251520"/>
            <a:ext cx="4772331" cy="3679580"/>
            <a:chOff x="24821" y="251520"/>
            <a:chExt cx="4772331" cy="3679580"/>
          </a:xfrm>
        </p:grpSpPr>
        <p:sp>
          <p:nvSpPr>
            <p:cNvPr id="6" name="TextBox 12"/>
            <p:cNvSpPr txBox="1">
              <a:spLocks noChangeArrowheads="1"/>
            </p:cNvSpPr>
            <p:nvPr/>
          </p:nvSpPr>
          <p:spPr bwMode="auto">
            <a:xfrm rot="16200000">
              <a:off x="27683" y="669032"/>
              <a:ext cx="11430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en-US" sz="14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WT </a:t>
              </a:r>
              <a:r>
                <a:rPr lang="en-US" altLang="en-US" sz="14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+ IL1</a:t>
              </a:r>
              <a:r>
                <a:rPr lang="el-GR" altLang="en-US" sz="14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β</a:t>
              </a:r>
              <a:endParaRPr lang="en-US" altLang="en-US" sz="14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12"/>
            <p:cNvSpPr txBox="1">
              <a:spLocks noChangeArrowheads="1"/>
            </p:cNvSpPr>
            <p:nvPr/>
          </p:nvSpPr>
          <p:spPr bwMode="auto">
            <a:xfrm rot="16200000">
              <a:off x="295177" y="707926"/>
              <a:ext cx="106521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en-US" sz="14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OX-1 </a:t>
              </a:r>
              <a:r>
                <a:rPr lang="en-US" altLang="en-US" sz="1400" b="1" baseline="30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-/-</a:t>
              </a:r>
            </a:p>
          </p:txBody>
        </p:sp>
        <p:sp>
          <p:nvSpPr>
            <p:cNvPr id="5" name="TextBox 14"/>
            <p:cNvSpPr txBox="1">
              <a:spLocks noChangeArrowheads="1"/>
            </p:cNvSpPr>
            <p:nvPr/>
          </p:nvSpPr>
          <p:spPr bwMode="auto">
            <a:xfrm>
              <a:off x="24821" y="355764"/>
              <a:ext cx="38496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en-US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altLang="en-US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12"/>
            <p:cNvSpPr txBox="1">
              <a:spLocks noChangeArrowheads="1"/>
            </p:cNvSpPr>
            <p:nvPr/>
          </p:nvSpPr>
          <p:spPr bwMode="auto">
            <a:xfrm rot="16200000">
              <a:off x="557908" y="745232"/>
              <a:ext cx="9906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en-US" sz="14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OX-2 </a:t>
              </a:r>
              <a:r>
                <a:rPr lang="en-US" altLang="en-US" sz="1400" b="1" baseline="30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-/-</a:t>
              </a: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525363" y="1331640"/>
              <a:ext cx="4271789" cy="2599460"/>
              <a:chOff x="525363" y="1331640"/>
              <a:chExt cx="4271789" cy="2599460"/>
            </a:xfrm>
          </p:grpSpPr>
          <p:pic>
            <p:nvPicPr>
              <p:cNvPr id="7" name="Picture 11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5363" y="1340300"/>
                <a:ext cx="4203700" cy="25908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Rectangle 1"/>
              <p:cNvSpPr/>
              <p:nvPr/>
            </p:nvSpPr>
            <p:spPr>
              <a:xfrm>
                <a:off x="1124744" y="1331640"/>
                <a:ext cx="2160240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Inflammatory response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1124744" y="1547664"/>
                <a:ext cx="1872208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Chemotaxis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1124744" y="1763688"/>
                <a:ext cx="2160240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Innate immune response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1124744" y="1907704"/>
                <a:ext cx="3024336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Negative regulation of apoptosis process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1124744" y="2123728"/>
                <a:ext cx="3672408" cy="2076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Positive regulator of smooth muscle cell migrat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1124744" y="2339752"/>
                <a:ext cx="3024336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Regulation of cell proliferat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1124744" y="2483768"/>
                <a:ext cx="3024336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Positive Chemotaxis</a:t>
                </a:r>
                <a:endParaRPr lang="en-US" sz="14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1124744" y="2699792"/>
                <a:ext cx="2952328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Actin cytoskeleton reorganizat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1124744" y="2915816"/>
                <a:ext cx="3024336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Prostaglandin biosynthesis process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1124744" y="3059832"/>
                <a:ext cx="3024336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Positive regulator of fibroblast proliferat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1124744" y="3275856"/>
                <a:ext cx="3024336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Metabolic process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1124744" y="3419872"/>
                <a:ext cx="3024336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Positive regulator of gene express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1124744" y="3635896"/>
                <a:ext cx="3024336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 smtClean="0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Negative regulator of gene expression</a:t>
                </a:r>
                <a:endPara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p:txBody>
          </p:sp>
        </p:grpSp>
      </p:grpSp>
      <p:grpSp>
        <p:nvGrpSpPr>
          <p:cNvPr id="23" name="Group 22"/>
          <p:cNvGrpSpPr/>
          <p:nvPr/>
        </p:nvGrpSpPr>
        <p:grpSpPr>
          <a:xfrm>
            <a:off x="44624" y="3995936"/>
            <a:ext cx="6789876" cy="2952328"/>
            <a:chOff x="44624" y="3995936"/>
            <a:chExt cx="6789876" cy="2952328"/>
          </a:xfrm>
        </p:grpSpPr>
        <p:cxnSp>
          <p:nvCxnSpPr>
            <p:cNvPr id="18" name="Straight Arrow Connector 6"/>
            <p:cNvCxnSpPr>
              <a:cxnSpLocks noChangeShapeType="1"/>
            </p:cNvCxnSpPr>
            <p:nvPr/>
          </p:nvCxnSpPr>
          <p:spPr bwMode="auto">
            <a:xfrm flipH="1">
              <a:off x="537920" y="6124774"/>
              <a:ext cx="381103" cy="524557"/>
            </a:xfrm>
            <a:prstGeom prst="straightConnector1">
              <a:avLst/>
            </a:prstGeom>
            <a:noFill/>
            <a:ln w="19050" algn="ctr">
              <a:solidFill>
                <a:srgbClr val="FF9933"/>
              </a:solidFill>
              <a:round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0" name="TextBox 14"/>
            <p:cNvSpPr txBox="1">
              <a:spLocks noChangeArrowheads="1"/>
            </p:cNvSpPr>
            <p:nvPr/>
          </p:nvSpPr>
          <p:spPr bwMode="auto">
            <a:xfrm>
              <a:off x="44624" y="6578932"/>
              <a:ext cx="39131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en-US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altLang="en-US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3212976" y="4788024"/>
              <a:ext cx="3621524" cy="1461342"/>
              <a:chOff x="609600" y="2963780"/>
              <a:chExt cx="4277075" cy="1961145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609600" y="4191000"/>
                <a:ext cx="1414578" cy="3717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Non-significant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2231274" y="2963780"/>
                <a:ext cx="2448502" cy="2606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27" name="组合 26"/>
              <p:cNvGrpSpPr/>
              <p:nvPr/>
            </p:nvGrpSpPr>
            <p:grpSpPr>
              <a:xfrm>
                <a:off x="609600" y="3200400"/>
                <a:ext cx="4277075" cy="1048084"/>
                <a:chOff x="609600" y="3066716"/>
                <a:chExt cx="4277075" cy="1048084"/>
              </a:xfrm>
            </p:grpSpPr>
            <p:sp>
              <p:nvSpPr>
                <p:cNvPr id="31" name="TextBox 30"/>
                <p:cNvSpPr txBox="1"/>
                <p:nvPr/>
              </p:nvSpPr>
              <p:spPr>
                <a:xfrm>
                  <a:off x="609600" y="3447716"/>
                  <a:ext cx="1052983" cy="3717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itchFamily="34" charset="0"/>
                      <a:cs typeface="Arial" pitchFamily="34" charset="0"/>
                    </a:rPr>
                    <a:t>S</a:t>
                  </a:r>
                  <a:r>
                    <a:rPr lang="en-US" altLang="zh-CN" sz="1200" dirty="0" smtClean="0">
                      <a:latin typeface="Arial" pitchFamily="34" charset="0"/>
                      <a:cs typeface="Arial" pitchFamily="34" charset="0"/>
                    </a:rPr>
                    <a:t>ignificant</a:t>
                  </a:r>
                  <a:endParaRPr lang="zh-CN" altLang="en-U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32" name="Picture 8" descr="C:\Users\khademul\Desktop\Manuscrip3_Figures\p-value-scale-2.jpg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8595" r="33158" b="30968"/>
                <a:stretch/>
              </p:blipFill>
              <p:spPr bwMode="auto">
                <a:xfrm>
                  <a:off x="1964656" y="3429872"/>
                  <a:ext cx="2488324" cy="3865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33" name="矩形 32"/>
                <p:cNvSpPr/>
                <p:nvPr/>
              </p:nvSpPr>
              <p:spPr>
                <a:xfrm>
                  <a:off x="1947506" y="3854116"/>
                  <a:ext cx="2622194" cy="26068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dirty="0" smtClean="0"/>
                    <a:t>00</a:t>
                  </a:r>
                  <a:endParaRPr lang="zh-CN" altLang="en-US" dirty="0"/>
                </a:p>
              </p:txBody>
            </p:sp>
            <p:sp>
              <p:nvSpPr>
                <p:cNvPr id="34" name="矩形 33"/>
                <p:cNvSpPr/>
                <p:nvPr/>
              </p:nvSpPr>
              <p:spPr>
                <a:xfrm>
                  <a:off x="1970281" y="3066716"/>
                  <a:ext cx="2449006" cy="35827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5" name="矩形 34"/>
                <p:cNvSpPr/>
                <p:nvPr/>
              </p:nvSpPr>
              <p:spPr>
                <a:xfrm>
                  <a:off x="4832680" y="3424992"/>
                  <a:ext cx="53995" cy="39704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1777421" y="3719781"/>
                  <a:ext cx="3019986" cy="3717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 smtClean="0">
                      <a:latin typeface="Arial" pitchFamily="34" charset="0"/>
                      <a:cs typeface="Arial" pitchFamily="34" charset="0"/>
                    </a:rPr>
                    <a:t>0.0                                           0.05</a:t>
                  </a:r>
                  <a:endParaRPr lang="zh-CN" altLang="en-U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pic>
            <p:nvPicPr>
              <p:cNvPr id="28" name="Picture 8" descr="C:\Users\khademul\Desktop\Manuscrip3_Figures\p-value-scale-2.jpg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315" t="40491" r="24135" b="31684"/>
              <a:stretch/>
            </p:blipFill>
            <p:spPr bwMode="auto">
              <a:xfrm>
                <a:off x="2010322" y="4240008"/>
                <a:ext cx="2443459" cy="35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1777421" y="4553188"/>
                <a:ext cx="2968872" cy="3717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0.05                                          1.0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027546" y="3224638"/>
                <a:ext cx="2133984" cy="3717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i="1" dirty="0" smtClean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 value for enrichment 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44624" y="3995936"/>
              <a:ext cx="3240360" cy="2160240"/>
              <a:chOff x="44624" y="3995936"/>
              <a:chExt cx="3240360" cy="2160240"/>
            </a:xfrm>
          </p:grpSpPr>
          <p:grpSp>
            <p:nvGrpSpPr>
              <p:cNvPr id="10" name="组合 9"/>
              <p:cNvGrpSpPr/>
              <p:nvPr/>
            </p:nvGrpSpPr>
            <p:grpSpPr>
              <a:xfrm>
                <a:off x="44624" y="3995936"/>
                <a:ext cx="2766596" cy="2128838"/>
                <a:chOff x="4916904" y="1679575"/>
                <a:chExt cx="2766596" cy="2128838"/>
              </a:xfrm>
            </p:grpSpPr>
            <p:sp>
              <p:nvSpPr>
                <p:cNvPr id="11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916904" y="1859585"/>
                  <a:ext cx="417096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r>
                    <a:rPr lang="en-US" altLang="en-US" b="1" dirty="0" smtClean="0">
                      <a:latin typeface="Arial" pitchFamily="34" charset="0"/>
                      <a:cs typeface="Arial" pitchFamily="34" charset="0"/>
                    </a:rPr>
                    <a:t>B</a:t>
                  </a:r>
                  <a:r>
                    <a:rPr lang="en-US" altLang="en-US" b="1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    </a:t>
                  </a:r>
                  <a:endParaRPr lang="en-US" altLang="en-US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12" name="Picture 12" descr="C:\Users\khademul\Desktop\Untitled Folder\GOMF_mif.png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10200" y="2830513"/>
                  <a:ext cx="2273300" cy="9779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3" name="TextBox 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80769" y="2132806"/>
                  <a:ext cx="1214438" cy="3079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/>
                <a:p>
                  <a:r>
                    <a:rPr lang="en-US" altLang="en-US" sz="1400" b="1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T </a:t>
                  </a:r>
                  <a:r>
                    <a:rPr lang="en-US" altLang="en-US" sz="1400" b="1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+ IL1</a:t>
                  </a:r>
                  <a:r>
                    <a:rPr lang="el-GR" altLang="en-US" sz="1400" b="1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β</a:t>
                  </a:r>
                  <a:endParaRPr lang="en-US" altLang="en-US" sz="14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" name="TextBox 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01432" y="2132806"/>
                  <a:ext cx="1214438" cy="3079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/>
                <a:p>
                  <a:r>
                    <a:rPr lang="en-US" altLang="en-US" sz="1400" b="1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COX-1 </a:t>
                  </a:r>
                  <a:r>
                    <a:rPr lang="en-US" altLang="en-US" sz="1400" b="1" baseline="300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-/-</a:t>
                  </a:r>
                </a:p>
              </p:txBody>
            </p:sp>
            <p:sp>
              <p:nvSpPr>
                <p:cNvPr id="15" name="TextBox 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349876" y="2206625"/>
                  <a:ext cx="1066800" cy="3079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/>
                <a:p>
                  <a:r>
                    <a:rPr lang="en-US" altLang="en-US" sz="1400" b="1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COX-2 </a:t>
                  </a:r>
                  <a:r>
                    <a:rPr lang="en-US" altLang="en-US" sz="1400" b="1" baseline="300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-/-</a:t>
                  </a:r>
                </a:p>
              </p:txBody>
            </p:sp>
          </p:grpSp>
          <p:grpSp>
            <p:nvGrpSpPr>
              <p:cNvPr id="4" name="Group 3"/>
              <p:cNvGrpSpPr/>
              <p:nvPr/>
            </p:nvGrpSpPr>
            <p:grpSpPr>
              <a:xfrm>
                <a:off x="1124744" y="5148064"/>
                <a:ext cx="2160240" cy="1008112"/>
                <a:chOff x="1124744" y="5148064"/>
                <a:chExt cx="2160240" cy="1008112"/>
              </a:xfrm>
            </p:grpSpPr>
            <p:sp>
              <p:nvSpPr>
                <p:cNvPr id="49" name="Rectangle 48"/>
                <p:cNvSpPr/>
                <p:nvPr/>
              </p:nvSpPr>
              <p:spPr>
                <a:xfrm>
                  <a:off x="1124744" y="5148064"/>
                  <a:ext cx="2160240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dirty="0" smtClean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ytokine activity</a:t>
                  </a:r>
                  <a:endParaRPr lang="en-US" sz="1200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50" name="Rectangle 49"/>
                <p:cNvSpPr/>
                <p:nvPr/>
              </p:nvSpPr>
              <p:spPr>
                <a:xfrm>
                  <a:off x="1124744" y="5364088"/>
                  <a:ext cx="2088232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dirty="0" smtClean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Growth factor activity</a:t>
                  </a:r>
                  <a:endParaRPr lang="en-US" sz="1200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51" name="Rectangle 50"/>
                <p:cNvSpPr/>
                <p:nvPr/>
              </p:nvSpPr>
              <p:spPr>
                <a:xfrm>
                  <a:off x="1124744" y="5580112"/>
                  <a:ext cx="2160240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dirty="0" smtClean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lcium ion binding</a:t>
                  </a:r>
                  <a:endParaRPr lang="en-US" sz="1200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52" name="Rectangle 51"/>
                <p:cNvSpPr/>
                <p:nvPr/>
              </p:nvSpPr>
              <p:spPr>
                <a:xfrm>
                  <a:off x="1124744" y="5796136"/>
                  <a:ext cx="2160240" cy="144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dirty="0" smtClean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hemoattractant activity</a:t>
                  </a:r>
                  <a:endParaRPr lang="en-US" sz="1200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53" name="Rectangle 52"/>
                <p:cNvSpPr/>
                <p:nvPr/>
              </p:nvSpPr>
              <p:spPr>
                <a:xfrm>
                  <a:off x="1124744" y="5940152"/>
                  <a:ext cx="2160240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sz="1200" dirty="0" smtClean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Isomerase activity</a:t>
                  </a:r>
                  <a:endParaRPr lang="en-US" sz="1200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</p:grpSp>
        </p:grpSp>
        <p:cxnSp>
          <p:nvCxnSpPr>
            <p:cNvPr id="19" name="Straight Arrow Connector 8"/>
            <p:cNvCxnSpPr>
              <a:cxnSpLocks noChangeShapeType="1"/>
            </p:cNvCxnSpPr>
            <p:nvPr/>
          </p:nvCxnSpPr>
          <p:spPr bwMode="auto">
            <a:xfrm>
              <a:off x="1073011" y="6124774"/>
              <a:ext cx="5493097" cy="524557"/>
            </a:xfrm>
            <a:prstGeom prst="straightConnector1">
              <a:avLst/>
            </a:prstGeom>
            <a:noFill/>
            <a:ln w="19050" algn="ctr">
              <a:solidFill>
                <a:srgbClr val="FF9933"/>
              </a:solidFill>
              <a:round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2935158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170</Words>
  <Application>Microsoft Office PowerPoint</Application>
  <PresentationFormat>全屏显示(4:3)</PresentationFormat>
  <Paragraphs>64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ditor editor</dc:creator>
  <cp:lastModifiedBy>[谢珊珊]</cp:lastModifiedBy>
  <cp:revision>19</cp:revision>
  <dcterms:created xsi:type="dcterms:W3CDTF">2017-11-29T08:19:20Z</dcterms:created>
  <dcterms:modified xsi:type="dcterms:W3CDTF">2017-12-09T05:08:25Z</dcterms:modified>
</cp:coreProperties>
</file>